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DBA2CE-4BE9-43AB-8285-91D5E2626D7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E677CC-1E84-4F00-B2D7-FAE546DA20C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E5A7A6-0887-4FD9-9AD7-5D9A0287C46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27DECB-F060-44D3-8A07-22714C536A9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DA9842-B6FE-4DA5-9D5E-78CE564A3C8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935F9F-04C6-4972-9FF0-87D885C01CD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FADCF2-3106-4FBD-BB70-59F2F50955B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7A9787-7C35-4F48-9C17-449E217B6DF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FFED4D-562B-44F5-90D9-1F9B6849A22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BE4636-4ACE-44D6-A828-25D6DEB309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2192F4-5619-4072-AE8F-D89543D7C8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9FACD6-4AAF-4467-B2E5-AABAEB6440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5378836-76E0-4012-A6BC-0D33FC7ABE8D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aMKII.1 regulates Clk and Cyc transcriptional activity and exhibits strain specific splice variant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Content Placeholder 3" descr=""/>
          <p:cNvPicPr/>
          <p:nvPr/>
        </p:nvPicPr>
        <p:blipFill>
          <a:blip r:embed="rId1"/>
          <a:stretch/>
        </p:blipFill>
        <p:spPr>
          <a:xfrm>
            <a:off x="2446200" y="2463840"/>
            <a:ext cx="4251600" cy="196056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5" descr=""/>
          <p:cNvPicPr/>
          <p:nvPr/>
        </p:nvPicPr>
        <p:blipFill>
          <a:blip r:embed="rId2"/>
          <a:stretch/>
        </p:blipFill>
        <p:spPr>
          <a:xfrm>
            <a:off x="6985080" y="6222960"/>
            <a:ext cx="1333440" cy="279360"/>
          </a:xfrm>
          <a:prstGeom prst="rect">
            <a:avLst/>
          </a:prstGeom>
          <a:ln w="0">
            <a:noFill/>
          </a:ln>
        </p:spPr>
      </p:pic>
      <p:sp>
        <p:nvSpPr>
          <p:cNvPr id="44" name="Title 1"/>
          <p:cNvSpPr/>
          <p:nvPr/>
        </p:nvSpPr>
        <p:spPr>
          <a:xfrm>
            <a:off x="444600" y="5851440"/>
            <a:ext cx="822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T S Kaiser </a:t>
            </a:r>
            <a:r>
              <a:rPr b="0" i="1" lang="fr-FR" sz="1200" spc="-1" strike="noStrike">
                <a:solidFill>
                  <a:srgbClr val="000000"/>
                </a:solidFill>
                <a:latin typeface="Arial"/>
              </a:rPr>
              <a:t>et al. Nature</a:t>
            </a: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1–5 (2016) doi:10.1038/nature2015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1-16T11:18:55Z</dcterms:created>
  <dc:creator>ravikumar.n</dc:creator>
  <dc:description/>
  <dc:language>en-US</dc:language>
  <cp:lastModifiedBy>ravikumar.n</cp:lastModifiedBy>
  <dcterms:modified xsi:type="dcterms:W3CDTF">2016-11-16T11:18:59Z</dcterms:modified>
  <cp:revision>1</cp:revision>
  <dc:subject/>
  <dc:title>CaMKII.1 regulates Clk and Cyc transcriptional activity and exhibits strain specific splice variants</dc:title>
</cp:coreProperties>
</file>